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8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1210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874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786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16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176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99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971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95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852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768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740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7A15F8-D3BF-4826-9DCA-626FFF840706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8B204-4C9F-4E0B-A3EF-EFE40FA904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630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22505"/>
            <a:ext cx="6858000" cy="80924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ADH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GLO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/>
          <a:srcRect r="10667"/>
          <a:stretch>
            <a:fillRect/>
          </a:stretch>
        </p:blipFill>
        <p:spPr bwMode="auto">
          <a:xfrm>
            <a:off x="0" y="708661"/>
            <a:ext cx="6858000" cy="73779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G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901107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c)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5800" y="571502"/>
            <a:ext cx="5486400" cy="83449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IT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907965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d)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571500"/>
            <a:ext cx="6858000" cy="85282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LFY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e)</a:t>
            </a: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r="8333"/>
          <a:stretch>
            <a:fillRect/>
          </a:stretch>
        </p:blipFill>
        <p:spPr bwMode="auto">
          <a:xfrm>
            <a:off x="0" y="845820"/>
            <a:ext cx="6858000" cy="71226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MADS1/FU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f)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 r="8333"/>
          <a:stretch>
            <a:fillRect/>
          </a:stretch>
        </p:blipFill>
        <p:spPr bwMode="auto">
          <a:xfrm>
            <a:off x="0" y="800100"/>
            <a:ext cx="6858000" cy="71797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lastid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g)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A1C5CAE-2354-894C-B7A8-9AD0DB8E14B3}"/>
              </a:ext>
            </a:extLst>
          </p:cNvPr>
          <p:cNvGrpSpPr/>
          <p:nvPr/>
        </p:nvGrpSpPr>
        <p:grpSpPr>
          <a:xfrm>
            <a:off x="0" y="731520"/>
            <a:ext cx="6858000" cy="7252059"/>
            <a:chOff x="0" y="731520"/>
            <a:chExt cx="6858000" cy="7252059"/>
          </a:xfrm>
        </p:grpSpPr>
        <p:pic>
          <p:nvPicPr>
            <p:cNvPr id="7170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0" y="731520"/>
              <a:ext cx="6858000" cy="72520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ED629A1-FC30-754C-860D-0EADF11CF591}"/>
                </a:ext>
              </a:extLst>
            </p:cNvPr>
            <p:cNvSpPr txBox="1"/>
            <p:nvPr/>
          </p:nvSpPr>
          <p:spPr>
            <a:xfrm>
              <a:off x="3113314" y="6370319"/>
              <a:ext cx="2103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‘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309ED32-2145-A746-BF18-FE45DA454404}"/>
                </a:ext>
              </a:extLst>
            </p:cNvPr>
            <p:cNvSpPr txBox="1"/>
            <p:nvPr/>
          </p:nvSpPr>
          <p:spPr>
            <a:xfrm>
              <a:off x="3600998" y="6370319"/>
              <a:ext cx="2103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’</a:t>
              </a: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67000" y="171450"/>
            <a:ext cx="148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/>
              <a:t>WAXY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54188" y="8805333"/>
            <a:ext cx="59901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Figure S6. 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Maximum likelihood trees for  individual loci with  1000 bootstrap replicates. (a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D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b)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LO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G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d) ITS, (e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LF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f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ADS1/FU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, (g) plastid, (h)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WAX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1911" y="248355"/>
            <a:ext cx="5192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h)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777240"/>
            <a:ext cx="6858000" cy="6889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84</Words>
  <Application>Microsoft Office PowerPoint</Application>
  <PresentationFormat>A4 Paper (210x297 mm)</PresentationFormat>
  <Paragraphs>2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McCarthy</dc:creator>
  <cp:lastModifiedBy>Elizabeth McCarthy</cp:lastModifiedBy>
  <cp:revision>3</cp:revision>
  <dcterms:created xsi:type="dcterms:W3CDTF">2018-09-30T06:01:31Z</dcterms:created>
  <dcterms:modified xsi:type="dcterms:W3CDTF">2019-03-11T03:02:56Z</dcterms:modified>
</cp:coreProperties>
</file>